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9" r:id="rId2"/>
  </p:sldIdLst>
  <p:sldSz cx="16200438" cy="12192000"/>
  <p:notesSz cx="9928225" cy="6797675"/>
  <p:custDataLst>
    <p:tags r:id="rId4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840">
          <p15:clr>
            <a:srgbClr val="A4A3A4"/>
          </p15:clr>
        </p15:guide>
        <p15:guide id="2" pos="5102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amia Boukhibar" initials="LB" lastIdx="1" clrIdx="0">
    <p:extLst/>
  </p:cmAuthor>
  <p:cmAuthor id="2" name="Microsoft Office User" initials="Office" lastIdx="1" clrIdx="1">
    <p:extLst/>
  </p:cmAuthor>
  <p:cmAuthor id="3" name="Microsoft Office User" initials="Office [2]" lastIdx="1" clrIdx="2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B3B3B3"/>
    <a:srgbClr val="616161"/>
    <a:srgbClr val="EEF4F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F2DE63D5-997A-4646-A377-4702673A728D}" styleName="Light Style 2 - Accent 3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</a:tcStyle>
    </a:band1H>
    <a:band1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1V>
    <a:band2V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3"/>
        </a:fillRef>
      </a:tcStyle>
    </a:firstRow>
  </a:tblStyle>
  <a:tblStyle styleId="{72833802-FEF1-4C79-8D5D-14CF1EAF98D9}" styleName="Light Style 2 - Accent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</a:tcStyle>
    </a:band1H>
    <a:band1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1V>
    <a:band2V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2"/>
        </a:fillRef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93D81CF-94F2-401A-BA57-92F5A7B2D0C5}" styleName="Medium Style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4034" autoAdjust="0"/>
    <p:restoredTop sz="96433" autoAdjust="0"/>
  </p:normalViewPr>
  <p:slideViewPr>
    <p:cSldViewPr snapToGrid="0">
      <p:cViewPr>
        <p:scale>
          <a:sx n="50" d="100"/>
          <a:sy n="50" d="100"/>
        </p:scale>
        <p:origin x="-1812" y="-702"/>
      </p:cViewPr>
      <p:guideLst>
        <p:guide orient="horz" pos="3840"/>
        <p:guide pos="510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tags" Target="tags/tag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9"/>
    </mc:Choice>
    <mc:Fallback>
      <c:style val="9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'EC sheet 2'!$I$27</c:f>
              <c:strCache>
                <c:ptCount val="1"/>
                <c:pt idx="0">
                  <c:v>Referring Team</c:v>
                </c:pt>
              </c:strCache>
            </c:strRef>
          </c:tx>
          <c:invertIfNegative val="0"/>
          <c:cat>
            <c:strRef>
              <c:f>'EC sheet 2'!$J$1:$Z$1</c:f>
              <c:strCache>
                <c:ptCount val="17"/>
                <c:pt idx="0">
                  <c:v>Audiology</c:v>
                </c:pt>
                <c:pt idx="1">
                  <c:v>Cardiology</c:v>
                </c:pt>
                <c:pt idx="2">
                  <c:v>Endocrinology</c:v>
                </c:pt>
                <c:pt idx="3">
                  <c:v>Gastroenterology</c:v>
                </c:pt>
                <c:pt idx="4">
                  <c:v>Clinical Genetics</c:v>
                </c:pt>
                <c:pt idx="5">
                  <c:v>Haematology</c:v>
                </c:pt>
                <c:pt idx="6">
                  <c:v>Immunology</c:v>
                </c:pt>
                <c:pt idx="7">
                  <c:v>Metabolic</c:v>
                </c:pt>
                <c:pt idx="8">
                  <c:v>Nephrology</c:v>
                </c:pt>
                <c:pt idx="9">
                  <c:v>Neuro/ Neuromuscular</c:v>
                </c:pt>
                <c:pt idx="10">
                  <c:v>Oncology</c:v>
                </c:pt>
                <c:pt idx="11">
                  <c:v>Ophthalmology</c:v>
                </c:pt>
                <c:pt idx="12">
                  <c:v>Palliative Care</c:v>
                </c:pt>
                <c:pt idx="13">
                  <c:v>PICU/ NICU/CICU</c:v>
                </c:pt>
                <c:pt idx="14">
                  <c:v>Respiratory</c:v>
                </c:pt>
                <c:pt idx="15">
                  <c:v>Surgery</c:v>
                </c:pt>
                <c:pt idx="16">
                  <c:v>Other </c:v>
                </c:pt>
              </c:strCache>
            </c:strRef>
          </c:cat>
          <c:val>
            <c:numRef>
              <c:f>'EC sheet 2'!$J$27:$Z$27</c:f>
              <c:numCache>
                <c:formatCode>General</c:formatCode>
                <c:ptCount val="17"/>
                <c:pt idx="0">
                  <c:v>0</c:v>
                </c:pt>
                <c:pt idx="1">
                  <c:v>1</c:v>
                </c:pt>
                <c:pt idx="2">
                  <c:v>0</c:v>
                </c:pt>
                <c:pt idx="3">
                  <c:v>0</c:v>
                </c:pt>
                <c:pt idx="4">
                  <c:v>9</c:v>
                </c:pt>
                <c:pt idx="5">
                  <c:v>0</c:v>
                </c:pt>
                <c:pt idx="6">
                  <c:v>5</c:v>
                </c:pt>
                <c:pt idx="7">
                  <c:v>1</c:v>
                </c:pt>
                <c:pt idx="8">
                  <c:v>2</c:v>
                </c:pt>
                <c:pt idx="9">
                  <c:v>1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3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</c:numCache>
            </c:numRef>
          </c:val>
        </c:ser>
        <c:ser>
          <c:idx val="1"/>
          <c:order val="1"/>
          <c:tx>
            <c:strRef>
              <c:f>'EC sheet 2'!$I$28</c:f>
              <c:strCache>
                <c:ptCount val="1"/>
                <c:pt idx="0">
                  <c:v>Other Patient Consult</c:v>
                </c:pt>
              </c:strCache>
            </c:strRef>
          </c:tx>
          <c:invertIfNegative val="0"/>
          <c:cat>
            <c:strRef>
              <c:f>'EC sheet 2'!$J$1:$Z$1</c:f>
              <c:strCache>
                <c:ptCount val="17"/>
                <c:pt idx="0">
                  <c:v>Audiology</c:v>
                </c:pt>
                <c:pt idx="1">
                  <c:v>Cardiology</c:v>
                </c:pt>
                <c:pt idx="2">
                  <c:v>Endocrinology</c:v>
                </c:pt>
                <c:pt idx="3">
                  <c:v>Gastroenterology</c:v>
                </c:pt>
                <c:pt idx="4">
                  <c:v>Clinical Genetics</c:v>
                </c:pt>
                <c:pt idx="5">
                  <c:v>Haematology</c:v>
                </c:pt>
                <c:pt idx="6">
                  <c:v>Immunology</c:v>
                </c:pt>
                <c:pt idx="7">
                  <c:v>Metabolic</c:v>
                </c:pt>
                <c:pt idx="8">
                  <c:v>Nephrology</c:v>
                </c:pt>
                <c:pt idx="9">
                  <c:v>Neuro/ Neuromuscular</c:v>
                </c:pt>
                <c:pt idx="10">
                  <c:v>Oncology</c:v>
                </c:pt>
                <c:pt idx="11">
                  <c:v>Ophthalmology</c:v>
                </c:pt>
                <c:pt idx="12">
                  <c:v>Palliative Care</c:v>
                </c:pt>
                <c:pt idx="13">
                  <c:v>PICU/ NICU/CICU</c:v>
                </c:pt>
                <c:pt idx="14">
                  <c:v>Respiratory</c:v>
                </c:pt>
                <c:pt idx="15">
                  <c:v>Surgery</c:v>
                </c:pt>
                <c:pt idx="16">
                  <c:v>Other </c:v>
                </c:pt>
              </c:strCache>
            </c:strRef>
          </c:cat>
          <c:val>
            <c:numRef>
              <c:f>'EC sheet 2'!$J$28:$Z$28</c:f>
              <c:numCache>
                <c:formatCode>General</c:formatCode>
                <c:ptCount val="17"/>
                <c:pt idx="0">
                  <c:v>8</c:v>
                </c:pt>
                <c:pt idx="1">
                  <c:v>12</c:v>
                </c:pt>
                <c:pt idx="2">
                  <c:v>9</c:v>
                </c:pt>
                <c:pt idx="3">
                  <c:v>9</c:v>
                </c:pt>
                <c:pt idx="4">
                  <c:v>11</c:v>
                </c:pt>
                <c:pt idx="5">
                  <c:v>7</c:v>
                </c:pt>
                <c:pt idx="6">
                  <c:v>5</c:v>
                </c:pt>
                <c:pt idx="7">
                  <c:v>7</c:v>
                </c:pt>
                <c:pt idx="8">
                  <c:v>4</c:v>
                </c:pt>
                <c:pt idx="9">
                  <c:v>6</c:v>
                </c:pt>
                <c:pt idx="10">
                  <c:v>3</c:v>
                </c:pt>
                <c:pt idx="11">
                  <c:v>16</c:v>
                </c:pt>
                <c:pt idx="12">
                  <c:v>8</c:v>
                </c:pt>
                <c:pt idx="13">
                  <c:v>17</c:v>
                </c:pt>
                <c:pt idx="14">
                  <c:v>13</c:v>
                </c:pt>
                <c:pt idx="15">
                  <c:v>9</c:v>
                </c:pt>
                <c:pt idx="16">
                  <c:v>9</c:v>
                </c:pt>
              </c:numCache>
            </c:numRef>
          </c:val>
        </c:ser>
        <c:ser>
          <c:idx val="2"/>
          <c:order val="2"/>
          <c:tx>
            <c:strRef>
              <c:f>'EC sheet 2'!$I$29</c:f>
              <c:strCache>
                <c:ptCount val="1"/>
                <c:pt idx="0">
                  <c:v>No Involvement</c:v>
                </c:pt>
              </c:strCache>
            </c:strRef>
          </c:tx>
          <c:invertIfNegative val="0"/>
          <c:cat>
            <c:strRef>
              <c:f>'EC sheet 2'!$J$1:$Z$1</c:f>
              <c:strCache>
                <c:ptCount val="17"/>
                <c:pt idx="0">
                  <c:v>Audiology</c:v>
                </c:pt>
                <c:pt idx="1">
                  <c:v>Cardiology</c:v>
                </c:pt>
                <c:pt idx="2">
                  <c:v>Endocrinology</c:v>
                </c:pt>
                <c:pt idx="3">
                  <c:v>Gastroenterology</c:v>
                </c:pt>
                <c:pt idx="4">
                  <c:v>Clinical Genetics</c:v>
                </c:pt>
                <c:pt idx="5">
                  <c:v>Haematology</c:v>
                </c:pt>
                <c:pt idx="6">
                  <c:v>Immunology</c:v>
                </c:pt>
                <c:pt idx="7">
                  <c:v>Metabolic</c:v>
                </c:pt>
                <c:pt idx="8">
                  <c:v>Nephrology</c:v>
                </c:pt>
                <c:pt idx="9">
                  <c:v>Neuro/ Neuromuscular</c:v>
                </c:pt>
                <c:pt idx="10">
                  <c:v>Oncology</c:v>
                </c:pt>
                <c:pt idx="11">
                  <c:v>Ophthalmology</c:v>
                </c:pt>
                <c:pt idx="12">
                  <c:v>Palliative Care</c:v>
                </c:pt>
                <c:pt idx="13">
                  <c:v>PICU/ NICU/CICU</c:v>
                </c:pt>
                <c:pt idx="14">
                  <c:v>Respiratory</c:v>
                </c:pt>
                <c:pt idx="15">
                  <c:v>Surgery</c:v>
                </c:pt>
                <c:pt idx="16">
                  <c:v>Other </c:v>
                </c:pt>
              </c:strCache>
            </c:strRef>
          </c:cat>
          <c:val>
            <c:numRef>
              <c:f>'EC sheet 2'!$J$29:$Z$29</c:f>
              <c:numCache>
                <c:formatCode>General</c:formatCode>
                <c:ptCount val="17"/>
                <c:pt idx="0">
                  <c:v>14</c:v>
                </c:pt>
                <c:pt idx="1">
                  <c:v>9</c:v>
                </c:pt>
                <c:pt idx="2">
                  <c:v>13</c:v>
                </c:pt>
                <c:pt idx="3">
                  <c:v>13</c:v>
                </c:pt>
                <c:pt idx="4">
                  <c:v>2</c:v>
                </c:pt>
                <c:pt idx="5">
                  <c:v>15</c:v>
                </c:pt>
                <c:pt idx="6">
                  <c:v>12</c:v>
                </c:pt>
                <c:pt idx="7">
                  <c:v>14</c:v>
                </c:pt>
                <c:pt idx="8">
                  <c:v>16</c:v>
                </c:pt>
                <c:pt idx="9">
                  <c:v>15</c:v>
                </c:pt>
                <c:pt idx="10">
                  <c:v>19</c:v>
                </c:pt>
                <c:pt idx="11">
                  <c:v>6</c:v>
                </c:pt>
                <c:pt idx="12">
                  <c:v>14</c:v>
                </c:pt>
                <c:pt idx="13">
                  <c:v>2</c:v>
                </c:pt>
                <c:pt idx="14">
                  <c:v>9</c:v>
                </c:pt>
                <c:pt idx="15">
                  <c:v>13</c:v>
                </c:pt>
                <c:pt idx="16">
                  <c:v>1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64340096"/>
        <c:axId val="164342016"/>
      </c:barChart>
      <c:catAx>
        <c:axId val="164340096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 sz="1800"/>
                </a:pPr>
                <a:r>
                  <a:rPr lang="en-GB" sz="1800"/>
                  <a:t>Specialty</a:t>
                </a:r>
              </a:p>
            </c:rich>
          </c:tx>
          <c:layout>
            <c:manualLayout>
              <c:xMode val="edge"/>
              <c:yMode val="edge"/>
              <c:x val="0.44123761021027402"/>
              <c:y val="0.96233068858744497"/>
            </c:manualLayout>
          </c:layout>
          <c:overlay val="0"/>
        </c:title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1600"/>
            </a:pPr>
            <a:endParaRPr lang="en-US"/>
          </a:p>
        </c:txPr>
        <c:crossAx val="164342016"/>
        <c:crosses val="autoZero"/>
        <c:auto val="1"/>
        <c:lblAlgn val="ctr"/>
        <c:lblOffset val="100"/>
        <c:noMultiLvlLbl val="0"/>
      </c:catAx>
      <c:valAx>
        <c:axId val="164342016"/>
        <c:scaling>
          <c:orientation val="minMax"/>
        </c:scaling>
        <c:delete val="0"/>
        <c:axPos val="l"/>
        <c:majorGridlines/>
        <c:title>
          <c:tx>
            <c:rich>
              <a:bodyPr rot="-5400000" vert="horz"/>
              <a:lstStyle/>
              <a:p>
                <a:pPr>
                  <a:defRPr sz="1600"/>
                </a:pPr>
                <a:r>
                  <a:rPr lang="en-GB" sz="1600"/>
                  <a:t>Number of RaPS Cases</a:t>
                </a:r>
              </a:p>
            </c:rich>
          </c:tx>
          <c:layout>
            <c:manualLayout>
              <c:xMode val="edge"/>
              <c:yMode val="edge"/>
              <c:x val="1.7576623699433645E-3"/>
              <c:y val="0.29883761661723451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1600"/>
            </a:pPr>
            <a:endParaRPr lang="en-US"/>
          </a:p>
        </c:txPr>
        <c:crossAx val="164340096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 sz="16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2125" cy="3413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622925" y="0"/>
            <a:ext cx="4303713" cy="3413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B4AA62E-F5F7-4644-A832-635A92716D2D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440113" y="849313"/>
            <a:ext cx="3048000" cy="22939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92188" y="3271838"/>
            <a:ext cx="7943850" cy="26765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456363"/>
            <a:ext cx="4302125" cy="3413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622925" y="6456363"/>
            <a:ext cx="4303713" cy="34131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0253162-EB7D-4FF6-B98E-CC90F3F4CE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20445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5033" y="1995312"/>
            <a:ext cx="13770372" cy="4244622"/>
          </a:xfrm>
        </p:spPr>
        <p:txBody>
          <a:bodyPr anchor="b"/>
          <a:lstStyle>
            <a:lvl1pPr algn="ctr">
              <a:defRPr sz="1063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25055" y="6403623"/>
            <a:ext cx="12150329" cy="2943577"/>
          </a:xfrm>
        </p:spPr>
        <p:txBody>
          <a:bodyPr/>
          <a:lstStyle>
            <a:lvl1pPr marL="0" indent="0" algn="ctr">
              <a:buNone/>
              <a:defRPr sz="4252"/>
            </a:lvl1pPr>
            <a:lvl2pPr marL="810021" indent="0" algn="ctr">
              <a:buNone/>
              <a:defRPr sz="3543"/>
            </a:lvl2pPr>
            <a:lvl3pPr marL="1620042" indent="0" algn="ctr">
              <a:buNone/>
              <a:defRPr sz="3189"/>
            </a:lvl3pPr>
            <a:lvl4pPr marL="2430064" indent="0" algn="ctr">
              <a:buNone/>
              <a:defRPr sz="2835"/>
            </a:lvl4pPr>
            <a:lvl5pPr marL="3240085" indent="0" algn="ctr">
              <a:buNone/>
              <a:defRPr sz="2835"/>
            </a:lvl5pPr>
            <a:lvl6pPr marL="4050106" indent="0" algn="ctr">
              <a:buNone/>
              <a:defRPr sz="2835"/>
            </a:lvl6pPr>
            <a:lvl7pPr marL="4860127" indent="0" algn="ctr">
              <a:buNone/>
              <a:defRPr sz="2835"/>
            </a:lvl7pPr>
            <a:lvl8pPr marL="5670149" indent="0" algn="ctr">
              <a:buNone/>
              <a:defRPr sz="2835"/>
            </a:lvl8pPr>
            <a:lvl9pPr marL="6480170" indent="0" algn="ctr">
              <a:buNone/>
              <a:defRPr sz="2835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54372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116634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593440" y="649111"/>
            <a:ext cx="3493219" cy="10332156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3781" y="649111"/>
            <a:ext cx="10277153" cy="10332156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42018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4574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5343" y="3039537"/>
            <a:ext cx="13972878" cy="5071532"/>
          </a:xfrm>
        </p:spPr>
        <p:txBody>
          <a:bodyPr anchor="b"/>
          <a:lstStyle>
            <a:lvl1pPr>
              <a:defRPr sz="1063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5343" y="8159048"/>
            <a:ext cx="13972878" cy="2666999"/>
          </a:xfrm>
        </p:spPr>
        <p:txBody>
          <a:bodyPr/>
          <a:lstStyle>
            <a:lvl1pPr marL="0" indent="0">
              <a:buNone/>
              <a:defRPr sz="4252">
                <a:solidFill>
                  <a:schemeClr val="tx1"/>
                </a:solidFill>
              </a:defRPr>
            </a:lvl1pPr>
            <a:lvl2pPr marL="810021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2pPr>
            <a:lvl3pPr marL="1620042" indent="0">
              <a:buNone/>
              <a:defRPr sz="3189">
                <a:solidFill>
                  <a:schemeClr val="tx1">
                    <a:tint val="75000"/>
                  </a:schemeClr>
                </a:solidFill>
              </a:defRPr>
            </a:lvl3pPr>
            <a:lvl4pPr marL="2430064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4pPr>
            <a:lvl5pPr marL="3240085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5pPr>
            <a:lvl6pPr marL="4050106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6pPr>
            <a:lvl7pPr marL="4860127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7pPr>
            <a:lvl8pPr marL="5670149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8pPr>
            <a:lvl9pPr marL="6480170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95290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3780" y="3245556"/>
            <a:ext cx="6885186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01472" y="3245556"/>
            <a:ext cx="6885186" cy="773571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88687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0" y="649114"/>
            <a:ext cx="13972878" cy="2356556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892" y="2988734"/>
            <a:ext cx="6853544" cy="1464732"/>
          </a:xfrm>
        </p:spPr>
        <p:txBody>
          <a:bodyPr anchor="b"/>
          <a:lstStyle>
            <a:lvl1pPr marL="0" indent="0">
              <a:buNone/>
              <a:defRPr sz="4252" b="1"/>
            </a:lvl1pPr>
            <a:lvl2pPr marL="810021" indent="0">
              <a:buNone/>
              <a:defRPr sz="3543" b="1"/>
            </a:lvl2pPr>
            <a:lvl3pPr marL="1620042" indent="0">
              <a:buNone/>
              <a:defRPr sz="3189" b="1"/>
            </a:lvl3pPr>
            <a:lvl4pPr marL="2430064" indent="0">
              <a:buNone/>
              <a:defRPr sz="2835" b="1"/>
            </a:lvl4pPr>
            <a:lvl5pPr marL="3240085" indent="0">
              <a:buNone/>
              <a:defRPr sz="2835" b="1"/>
            </a:lvl5pPr>
            <a:lvl6pPr marL="4050106" indent="0">
              <a:buNone/>
              <a:defRPr sz="2835" b="1"/>
            </a:lvl6pPr>
            <a:lvl7pPr marL="4860127" indent="0">
              <a:buNone/>
              <a:defRPr sz="2835" b="1"/>
            </a:lvl7pPr>
            <a:lvl8pPr marL="5670149" indent="0">
              <a:buNone/>
              <a:defRPr sz="2835" b="1"/>
            </a:lvl8pPr>
            <a:lvl9pPr marL="6480170" indent="0">
              <a:buNone/>
              <a:defRPr sz="2835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5892" y="4453467"/>
            <a:ext cx="6853544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01473" y="2988734"/>
            <a:ext cx="6887296" cy="1464732"/>
          </a:xfrm>
        </p:spPr>
        <p:txBody>
          <a:bodyPr anchor="b"/>
          <a:lstStyle>
            <a:lvl1pPr marL="0" indent="0">
              <a:buNone/>
              <a:defRPr sz="4252" b="1"/>
            </a:lvl1pPr>
            <a:lvl2pPr marL="810021" indent="0">
              <a:buNone/>
              <a:defRPr sz="3543" b="1"/>
            </a:lvl2pPr>
            <a:lvl3pPr marL="1620042" indent="0">
              <a:buNone/>
              <a:defRPr sz="3189" b="1"/>
            </a:lvl3pPr>
            <a:lvl4pPr marL="2430064" indent="0">
              <a:buNone/>
              <a:defRPr sz="2835" b="1"/>
            </a:lvl4pPr>
            <a:lvl5pPr marL="3240085" indent="0">
              <a:buNone/>
              <a:defRPr sz="2835" b="1"/>
            </a:lvl5pPr>
            <a:lvl6pPr marL="4050106" indent="0">
              <a:buNone/>
              <a:defRPr sz="2835" b="1"/>
            </a:lvl6pPr>
            <a:lvl7pPr marL="4860127" indent="0">
              <a:buNone/>
              <a:defRPr sz="2835" b="1"/>
            </a:lvl7pPr>
            <a:lvl8pPr marL="5670149" indent="0">
              <a:buNone/>
              <a:defRPr sz="2835" b="1"/>
            </a:lvl8pPr>
            <a:lvl9pPr marL="6480170" indent="0">
              <a:buNone/>
              <a:defRPr sz="2835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01473" y="4453467"/>
            <a:ext cx="6887296" cy="6550379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243822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38941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106073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0" y="812800"/>
            <a:ext cx="5225063" cy="2844800"/>
          </a:xfrm>
        </p:spPr>
        <p:txBody>
          <a:bodyPr anchor="b"/>
          <a:lstStyle>
            <a:lvl1pPr>
              <a:defRPr sz="5669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887296" y="1755425"/>
            <a:ext cx="8201472" cy="8664222"/>
          </a:xfrm>
        </p:spPr>
        <p:txBody>
          <a:bodyPr/>
          <a:lstStyle>
            <a:lvl1pPr>
              <a:defRPr sz="5669"/>
            </a:lvl1pPr>
            <a:lvl2pPr>
              <a:defRPr sz="4961"/>
            </a:lvl2pPr>
            <a:lvl3pPr>
              <a:defRPr sz="4252"/>
            </a:lvl3pPr>
            <a:lvl4pPr>
              <a:defRPr sz="3543"/>
            </a:lvl4pPr>
            <a:lvl5pPr>
              <a:defRPr sz="3543"/>
            </a:lvl5pPr>
            <a:lvl6pPr>
              <a:defRPr sz="3543"/>
            </a:lvl6pPr>
            <a:lvl7pPr>
              <a:defRPr sz="3543"/>
            </a:lvl7pPr>
            <a:lvl8pPr>
              <a:defRPr sz="3543"/>
            </a:lvl8pPr>
            <a:lvl9pPr>
              <a:defRPr sz="3543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5890" y="3657600"/>
            <a:ext cx="5225063" cy="6776156"/>
          </a:xfrm>
        </p:spPr>
        <p:txBody>
          <a:bodyPr/>
          <a:lstStyle>
            <a:lvl1pPr marL="0" indent="0">
              <a:buNone/>
              <a:defRPr sz="2835"/>
            </a:lvl1pPr>
            <a:lvl2pPr marL="810021" indent="0">
              <a:buNone/>
              <a:defRPr sz="2480"/>
            </a:lvl2pPr>
            <a:lvl3pPr marL="1620042" indent="0">
              <a:buNone/>
              <a:defRPr sz="2126"/>
            </a:lvl3pPr>
            <a:lvl4pPr marL="2430064" indent="0">
              <a:buNone/>
              <a:defRPr sz="1772"/>
            </a:lvl4pPr>
            <a:lvl5pPr marL="3240085" indent="0">
              <a:buNone/>
              <a:defRPr sz="1772"/>
            </a:lvl5pPr>
            <a:lvl6pPr marL="4050106" indent="0">
              <a:buNone/>
              <a:defRPr sz="1772"/>
            </a:lvl6pPr>
            <a:lvl7pPr marL="4860127" indent="0">
              <a:buNone/>
              <a:defRPr sz="1772"/>
            </a:lvl7pPr>
            <a:lvl8pPr marL="5670149" indent="0">
              <a:buNone/>
              <a:defRPr sz="1772"/>
            </a:lvl8pPr>
            <a:lvl9pPr marL="6480170" indent="0">
              <a:buNone/>
              <a:defRPr sz="1772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10873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890" y="812800"/>
            <a:ext cx="5225063" cy="2844800"/>
          </a:xfrm>
        </p:spPr>
        <p:txBody>
          <a:bodyPr anchor="b"/>
          <a:lstStyle>
            <a:lvl1pPr>
              <a:defRPr sz="5669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887296" y="1755425"/>
            <a:ext cx="8201472" cy="8664222"/>
          </a:xfrm>
        </p:spPr>
        <p:txBody>
          <a:bodyPr anchor="t"/>
          <a:lstStyle>
            <a:lvl1pPr marL="0" indent="0">
              <a:buNone/>
              <a:defRPr sz="5669"/>
            </a:lvl1pPr>
            <a:lvl2pPr marL="810021" indent="0">
              <a:buNone/>
              <a:defRPr sz="4961"/>
            </a:lvl2pPr>
            <a:lvl3pPr marL="1620042" indent="0">
              <a:buNone/>
              <a:defRPr sz="4252"/>
            </a:lvl3pPr>
            <a:lvl4pPr marL="2430064" indent="0">
              <a:buNone/>
              <a:defRPr sz="3543"/>
            </a:lvl4pPr>
            <a:lvl5pPr marL="3240085" indent="0">
              <a:buNone/>
              <a:defRPr sz="3543"/>
            </a:lvl5pPr>
            <a:lvl6pPr marL="4050106" indent="0">
              <a:buNone/>
              <a:defRPr sz="3543"/>
            </a:lvl6pPr>
            <a:lvl7pPr marL="4860127" indent="0">
              <a:buNone/>
              <a:defRPr sz="3543"/>
            </a:lvl7pPr>
            <a:lvl8pPr marL="5670149" indent="0">
              <a:buNone/>
              <a:defRPr sz="3543"/>
            </a:lvl8pPr>
            <a:lvl9pPr marL="6480170" indent="0">
              <a:buNone/>
              <a:defRPr sz="3543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5890" y="3657600"/>
            <a:ext cx="5225063" cy="6776156"/>
          </a:xfrm>
        </p:spPr>
        <p:txBody>
          <a:bodyPr/>
          <a:lstStyle>
            <a:lvl1pPr marL="0" indent="0">
              <a:buNone/>
              <a:defRPr sz="2835"/>
            </a:lvl1pPr>
            <a:lvl2pPr marL="810021" indent="0">
              <a:buNone/>
              <a:defRPr sz="2480"/>
            </a:lvl2pPr>
            <a:lvl3pPr marL="1620042" indent="0">
              <a:buNone/>
              <a:defRPr sz="2126"/>
            </a:lvl3pPr>
            <a:lvl4pPr marL="2430064" indent="0">
              <a:buNone/>
              <a:defRPr sz="1772"/>
            </a:lvl4pPr>
            <a:lvl5pPr marL="3240085" indent="0">
              <a:buNone/>
              <a:defRPr sz="1772"/>
            </a:lvl5pPr>
            <a:lvl6pPr marL="4050106" indent="0">
              <a:buNone/>
              <a:defRPr sz="1772"/>
            </a:lvl6pPr>
            <a:lvl7pPr marL="4860127" indent="0">
              <a:buNone/>
              <a:defRPr sz="1772"/>
            </a:lvl7pPr>
            <a:lvl8pPr marL="5670149" indent="0">
              <a:buNone/>
              <a:defRPr sz="1772"/>
            </a:lvl8pPr>
            <a:lvl9pPr marL="6480170" indent="0">
              <a:buNone/>
              <a:defRPr sz="1772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02305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3780" y="649114"/>
            <a:ext cx="13972878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3780" y="3245556"/>
            <a:ext cx="13972878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3780" y="11300181"/>
            <a:ext cx="3645099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2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FFAD5F-0209-4EDD-9685-1048075AF4F9}" type="datetimeFigureOut">
              <a:rPr lang="en-GB" smtClean="0"/>
              <a:t>19/03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66395" y="11300181"/>
            <a:ext cx="5467648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2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41559" y="11300181"/>
            <a:ext cx="3645099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26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FCB1DC6-39AC-42E7-BB45-6792B87974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77778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620042" rtl="0" eaLnBrk="1" latinLnBrk="0" hangingPunct="1">
        <a:lnSpc>
          <a:spcPct val="90000"/>
        </a:lnSpc>
        <a:spcBef>
          <a:spcPct val="0"/>
        </a:spcBef>
        <a:buNone/>
        <a:defRPr sz="779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5011" indent="-405011" algn="l" defTabSz="1620042" rtl="0" eaLnBrk="1" latinLnBrk="0" hangingPunct="1">
        <a:lnSpc>
          <a:spcPct val="90000"/>
        </a:lnSpc>
        <a:spcBef>
          <a:spcPts val="1772"/>
        </a:spcBef>
        <a:buFont typeface="Arial" panose="020B0604020202020204" pitchFamily="34" charset="0"/>
        <a:buChar char="•"/>
        <a:defRPr sz="4961" kern="1200">
          <a:solidFill>
            <a:schemeClr val="tx1"/>
          </a:solidFill>
          <a:latin typeface="+mn-lt"/>
          <a:ea typeface="+mn-ea"/>
          <a:cs typeface="+mn-cs"/>
        </a:defRPr>
      </a:lvl1pPr>
      <a:lvl2pPr marL="1215032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4252" kern="1200">
          <a:solidFill>
            <a:schemeClr val="tx1"/>
          </a:solidFill>
          <a:latin typeface="+mn-lt"/>
          <a:ea typeface="+mn-ea"/>
          <a:cs typeface="+mn-cs"/>
        </a:defRPr>
      </a:lvl2pPr>
      <a:lvl3pPr marL="2025053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835074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4pPr>
      <a:lvl5pPr marL="3645096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5pPr>
      <a:lvl6pPr marL="4455117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6pPr>
      <a:lvl7pPr marL="5265138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7pPr>
      <a:lvl8pPr marL="6075159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8pPr>
      <a:lvl9pPr marL="6885181" indent="-405011" algn="l" defTabSz="1620042" rtl="0" eaLnBrk="1" latinLnBrk="0" hangingPunct="1">
        <a:lnSpc>
          <a:spcPct val="90000"/>
        </a:lnSpc>
        <a:spcBef>
          <a:spcPts val="886"/>
        </a:spcBef>
        <a:buFont typeface="Arial" panose="020B0604020202020204" pitchFamily="34" charset="0"/>
        <a:buChar char="•"/>
        <a:defRPr sz="31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1pPr>
      <a:lvl2pPr marL="810021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2pPr>
      <a:lvl3pPr marL="1620042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3pPr>
      <a:lvl4pPr marL="2430064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4pPr>
      <a:lvl5pPr marL="3240085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5pPr>
      <a:lvl6pPr marL="4050106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6pPr>
      <a:lvl7pPr marL="4860127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7pPr>
      <a:lvl8pPr marL="5670149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8pPr>
      <a:lvl9pPr marL="6480170" algn="l" defTabSz="1620042" rtl="0" eaLnBrk="1" latinLnBrk="0" hangingPunct="1">
        <a:defRPr sz="318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50488291"/>
              </p:ext>
            </p:extLst>
          </p:nvPr>
        </p:nvGraphicFramePr>
        <p:xfrm>
          <a:off x="1017588" y="1409700"/>
          <a:ext cx="14451012" cy="99631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895349" y="800100"/>
            <a:ext cx="1267627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r>
              <a:rPr lang="en-GB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GB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pecialties Involved in Care of </a:t>
            </a:r>
            <a:r>
              <a:rPr lang="en-GB" sz="2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obands</a:t>
            </a:r>
            <a:r>
              <a:rPr lang="en-GB" sz="2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cruited to </a:t>
            </a:r>
            <a:r>
              <a:rPr lang="en-GB" sz="2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aPS</a:t>
            </a:r>
            <a:endParaRPr lang="en-GB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GB" sz="2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endParaRPr lang="en-GB" sz="2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9468114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PPRESENTATIONGUID" val="60d00e82-6d48-413a-9581-944960035fbc"/>
  <p:tag name="TPVERSION" val="8"/>
  <p:tag name="TPFULLVERSION" val="8.2.3.1"/>
  <p:tag name="PPTVERSION" val="14"/>
  <p:tag name="TPOS" val="2"/>
  <p:tag name="TPLASTSAVEVERSION" val="6.2 PC"/>
</p:tagLst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618</TotalTime>
  <Words>19</Words>
  <Application>Microsoft Office PowerPoint</Application>
  <PresentationFormat>Custom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CL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mia Boukhibar</dc:creator>
  <cp:lastModifiedBy>Hywel Williams</cp:lastModifiedBy>
  <cp:revision>151</cp:revision>
  <cp:lastPrinted>2018-02-12T11:49:05Z</cp:lastPrinted>
  <dcterms:created xsi:type="dcterms:W3CDTF">2017-06-01T14:01:27Z</dcterms:created>
  <dcterms:modified xsi:type="dcterms:W3CDTF">2018-03-19T09:33:14Z</dcterms:modified>
</cp:coreProperties>
</file>